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00" autoAdjust="0"/>
    <p:restoredTop sz="94660"/>
  </p:normalViewPr>
  <p:slideViewPr>
    <p:cSldViewPr snapToGrid="0">
      <p:cViewPr varScale="1">
        <p:scale>
          <a:sx n="72" d="100"/>
          <a:sy n="72" d="100"/>
        </p:scale>
        <p:origin x="72" y="57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DF38E8-52AC-821B-BD47-4C7362C71AE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E72EBB0-D071-1D2C-A20D-E4F0EC7C0D4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A11A2C9-9CF6-9D04-59FC-30B5C8A67C2D}"/>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CA14ADF4-E814-A84A-AE75-B9B363507A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D71DD1-3342-DCE3-5223-8054FC75F37E}"/>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33391514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B65EA6-62D4-8F28-5CEB-167EECAA0EB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9A373D-BC08-4F68-A7DA-7DBCC861778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541F858-F4E8-6FDA-099E-0B40B44D5B18}"/>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E4E70952-CCB5-8868-4101-2CCC2C88E1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B81403-E92E-AF4D-B022-8F27BB192F2B}"/>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38301046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27D674A-72BA-EEBC-1357-B929A3947F7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C8072AD-97F3-17BC-AAF8-09A069E4FC8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09AF75B-8142-0A20-47E4-7601F273A4EA}"/>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40AAF1DF-F0F3-DDE3-553C-2357F6393A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9016CD-F72C-C8DA-B234-DC92339C015E}"/>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4261488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5DA39E-6F04-C724-826B-A7A4677737D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699152-51A6-4AA7-5B0D-89329190498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1D6E4F-85C8-02AB-01F8-D039EFE5D4C0}"/>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18B445A1-2185-A8DF-CD73-0914901AEEF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B210AD-AC0A-37E5-C26E-2B61C352AE0B}"/>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5944740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F8F3FA-49A9-6944-2C22-5E050F94D2E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13D38DF-A31F-AB77-4CB1-2DCEB1AD0DC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9DEA942-ABE0-5721-1C08-DDECD0103A85}"/>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6F1C1CBC-239E-DA14-2917-564497B715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32D6BA-0617-04A3-A034-333ED1C14E1B}"/>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39832926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983D30-657C-D86F-7EA8-5C1B216737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ABA8484-3B90-E3E8-04FF-F7F780BFF3B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84AAEB6-0CE6-C6FD-4BEB-511C8A99F78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1B05479-5CB0-A95B-F81B-E0B577D20507}"/>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6" name="Footer Placeholder 5">
            <a:extLst>
              <a:ext uri="{FF2B5EF4-FFF2-40B4-BE49-F238E27FC236}">
                <a16:creationId xmlns:a16="http://schemas.microsoft.com/office/drawing/2014/main" id="{A57EC6EC-A6AF-62FF-88AC-1A6CAC13382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55A6C85-C7CD-4B51-7474-3B20F601D8AD}"/>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39504030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C69F1-6D4B-2C5C-7A88-BCADF043DD7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BA0D483-1230-4EFD-6FC8-FE8729FAE6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137DC2E-A402-59F5-03E2-0C8D2D00EDC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758F1F1-067C-4326-DAE9-743F8BA2943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8A1AAF9-B0D3-D953-C946-1FF771249EA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00ACC96-57F4-8C02-DA8B-ACF7E924A77D}"/>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8" name="Footer Placeholder 7">
            <a:extLst>
              <a:ext uri="{FF2B5EF4-FFF2-40B4-BE49-F238E27FC236}">
                <a16:creationId xmlns:a16="http://schemas.microsoft.com/office/drawing/2014/main" id="{A7012FC7-FD2C-D63A-C025-3E7FFE254F6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3DA18E5-9B1D-6710-7669-9283FAE14ACB}"/>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4064207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F8336D-2B34-311C-9096-13EF5A3BAB5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2E9075E-0746-7043-B158-21418DDCFCEF}"/>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4" name="Footer Placeholder 3">
            <a:extLst>
              <a:ext uri="{FF2B5EF4-FFF2-40B4-BE49-F238E27FC236}">
                <a16:creationId xmlns:a16="http://schemas.microsoft.com/office/drawing/2014/main" id="{2607A35C-A63B-2CB8-3123-A2C26EB4426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11D96D9-83AA-0469-EB19-914EC2FA7DF8}"/>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40854719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652A5C2-A19C-E494-1AAB-599AD78AB904}"/>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3" name="Footer Placeholder 2">
            <a:extLst>
              <a:ext uri="{FF2B5EF4-FFF2-40B4-BE49-F238E27FC236}">
                <a16:creationId xmlns:a16="http://schemas.microsoft.com/office/drawing/2014/main" id="{4509F642-4E43-918F-B1AD-7C8EA0E53C8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A9EC335-2619-1983-22DC-D29D734ACB71}"/>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37847808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5EF5DC-67EE-0706-E77C-557E0E7B5C9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7DFF1B1-B54B-B8C5-14EE-329E3563C31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BD37D17-352C-330F-76BD-948C8D3071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CE30AC9-B618-23D0-0C89-B2DF63C45381}"/>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6" name="Footer Placeholder 5">
            <a:extLst>
              <a:ext uri="{FF2B5EF4-FFF2-40B4-BE49-F238E27FC236}">
                <a16:creationId xmlns:a16="http://schemas.microsoft.com/office/drawing/2014/main" id="{B197BCF3-6184-4883-D5CC-714C8A8FD1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38EBD8-FEA9-3126-643B-E55E5446B92A}"/>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28450735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C369B-D34A-B6C5-D642-FF0A6F622E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AB6DD73-B5EF-1651-C5AC-8122B98F67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B21D03B-2B61-F633-7736-B4FEE9FB4E6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84D9B52-ED82-E6AD-1898-D4A4DCB7601A}"/>
              </a:ext>
            </a:extLst>
          </p:cNvPr>
          <p:cNvSpPr>
            <a:spLocks noGrp="1"/>
          </p:cNvSpPr>
          <p:nvPr>
            <p:ph type="dt" sz="half" idx="10"/>
          </p:nvPr>
        </p:nvSpPr>
        <p:spPr/>
        <p:txBody>
          <a:bodyPr/>
          <a:lstStyle/>
          <a:p>
            <a:fld id="{CAF4AE38-6E93-4874-AF9A-7F77274B6D34}" type="datetimeFigureOut">
              <a:rPr lang="en-US" smtClean="0"/>
              <a:t>4/8/2025</a:t>
            </a:fld>
            <a:endParaRPr lang="en-US"/>
          </a:p>
        </p:txBody>
      </p:sp>
      <p:sp>
        <p:nvSpPr>
          <p:cNvPr id="6" name="Footer Placeholder 5">
            <a:extLst>
              <a:ext uri="{FF2B5EF4-FFF2-40B4-BE49-F238E27FC236}">
                <a16:creationId xmlns:a16="http://schemas.microsoft.com/office/drawing/2014/main" id="{9EF0A52F-87A6-B3FE-0711-E1C3C603D6D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3317EF-25CB-090D-237A-91A3A97C8005}"/>
              </a:ext>
            </a:extLst>
          </p:cNvPr>
          <p:cNvSpPr>
            <a:spLocks noGrp="1"/>
          </p:cNvSpPr>
          <p:nvPr>
            <p:ph type="sldNum" sz="quarter" idx="12"/>
          </p:nvPr>
        </p:nvSpPr>
        <p:spPr/>
        <p:txBody>
          <a:bodyPr/>
          <a:lstStyle/>
          <a:p>
            <a:fld id="{B3E297DD-D1B8-47DA-8D59-B11F86842ED1}" type="slidenum">
              <a:rPr lang="en-US" smtClean="0"/>
              <a:t>‹#›</a:t>
            </a:fld>
            <a:endParaRPr lang="en-US"/>
          </a:p>
        </p:txBody>
      </p:sp>
    </p:spTree>
    <p:extLst>
      <p:ext uri="{BB962C8B-B14F-4D97-AF65-F5344CB8AC3E}">
        <p14:creationId xmlns:p14="http://schemas.microsoft.com/office/powerpoint/2010/main" val="2063239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830D3E5-0DE5-8142-9DCB-5CA4EB447A5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9A643CC-A99E-6229-4247-17C84784AE4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28D0D45-E453-77A3-6A83-3C17B7EA309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AF4AE38-6E93-4874-AF9A-7F77274B6D34}" type="datetimeFigureOut">
              <a:rPr lang="en-US" smtClean="0"/>
              <a:t>4/8/2025</a:t>
            </a:fld>
            <a:endParaRPr lang="en-US"/>
          </a:p>
        </p:txBody>
      </p:sp>
      <p:sp>
        <p:nvSpPr>
          <p:cNvPr id="5" name="Footer Placeholder 4">
            <a:extLst>
              <a:ext uri="{FF2B5EF4-FFF2-40B4-BE49-F238E27FC236}">
                <a16:creationId xmlns:a16="http://schemas.microsoft.com/office/drawing/2014/main" id="{9FC43377-95CA-9A79-43B8-3095D46B60F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0567D033-D703-5A71-DC67-068EF28564E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3E297DD-D1B8-47DA-8D59-B11F86842ED1}" type="slidenum">
              <a:rPr lang="en-US" smtClean="0"/>
              <a:t>‹#›</a:t>
            </a:fld>
            <a:endParaRPr lang="en-US"/>
          </a:p>
        </p:txBody>
      </p:sp>
    </p:spTree>
    <p:extLst>
      <p:ext uri="{BB962C8B-B14F-4D97-AF65-F5344CB8AC3E}">
        <p14:creationId xmlns:p14="http://schemas.microsoft.com/office/powerpoint/2010/main" val="23174788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69840DA-45C9-DBEB-8B61-004C15251F17}"/>
              </a:ext>
            </a:extLst>
          </p:cNvPr>
          <p:cNvPicPr>
            <a:picLocks noChangeAspect="1"/>
          </p:cNvPicPr>
          <p:nvPr/>
        </p:nvPicPr>
        <p:blipFill>
          <a:blip r:embed="rId2"/>
          <a:stretch>
            <a:fillRect/>
          </a:stretch>
        </p:blipFill>
        <p:spPr>
          <a:xfrm>
            <a:off x="3983393" y="0"/>
            <a:ext cx="4225214" cy="6858000"/>
          </a:xfrm>
          <a:prstGeom prst="rect">
            <a:avLst/>
          </a:prstGeom>
        </p:spPr>
      </p:pic>
    </p:spTree>
    <p:extLst>
      <p:ext uri="{BB962C8B-B14F-4D97-AF65-F5344CB8AC3E}">
        <p14:creationId xmlns:p14="http://schemas.microsoft.com/office/powerpoint/2010/main" val="40583644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8FAD229-C8CA-68B1-C58A-420742C02007}"/>
              </a:ext>
            </a:extLst>
          </p:cNvPr>
          <p:cNvSpPr txBox="1"/>
          <p:nvPr/>
        </p:nvSpPr>
        <p:spPr>
          <a:xfrm>
            <a:off x="3048000" y="683024"/>
            <a:ext cx="6096000" cy="5491953"/>
          </a:xfrm>
          <a:prstGeom prst="rect">
            <a:avLst/>
          </a:prstGeom>
          <a:noFill/>
        </p:spPr>
        <p:txBody>
          <a:bodyPr wrap="square">
            <a:spAutoFit/>
          </a:bodyPr>
          <a:lstStyle/>
          <a:p>
            <a:pPr marL="0" marR="0">
              <a:lnSpc>
                <a:spcPct val="115000"/>
              </a:lnSpc>
              <a:spcAft>
                <a:spcPts val="800"/>
              </a:spcAft>
            </a:pPr>
            <a:r>
              <a:rPr lang="en-GB" sz="1800" b="1" kern="100" dirty="0">
                <a:effectLst/>
                <a:latin typeface="Aptos" panose="020B0004020202020204" pitchFamily="34" charset="0"/>
                <a:ea typeface="Aptos" panose="020B0004020202020204" pitchFamily="34" charset="0"/>
                <a:cs typeface="Times New Roman" panose="02020603050405020304" pitchFamily="18" charset="0"/>
              </a:rPr>
              <a:t>Supplementary Figure 2: </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Additional RNA sequencing analysis performed from CANCAP03 study.  Gene set enrichment analysis of differential pathway enrichment between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olaparib+degarelix</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and cohorts (B) Overlap between specific signatures which were used in gene set enrichment analysis in conjunction with the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MSigDB</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Hallmark signatures.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Prolaris</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from</a:t>
            </a:r>
            <a:r>
              <a:rPr lang="en-GB" sz="1800" kern="100" baseline="30000" dirty="0">
                <a:effectLst/>
                <a:latin typeface="Aptos" panose="020B0004020202020204" pitchFamily="34" charset="0"/>
                <a:ea typeface="Aptos" panose="020B0004020202020204" pitchFamily="34" charset="0"/>
                <a:cs typeface="Times New Roman" panose="02020603050405020304" pitchFamily="18" charset="0"/>
              </a:rPr>
              <a:t>42</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BRCAness</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from</a:t>
            </a:r>
            <a:r>
              <a:rPr lang="en-GB" sz="1800" kern="100" baseline="30000" dirty="0">
                <a:effectLst/>
                <a:latin typeface="Aptos" panose="020B0004020202020204" pitchFamily="34" charset="0"/>
                <a:ea typeface="Aptos" panose="020B0004020202020204" pitchFamily="34" charset="0"/>
                <a:cs typeface="Times New Roman" panose="02020603050405020304" pitchFamily="18" charset="0"/>
              </a:rPr>
              <a:t>43</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HRD from</a:t>
            </a:r>
            <a:r>
              <a:rPr lang="en-GB" sz="1800" kern="100" baseline="30000" dirty="0">
                <a:effectLst/>
                <a:latin typeface="Aptos" panose="020B0004020202020204" pitchFamily="34" charset="0"/>
                <a:ea typeface="Aptos" panose="020B0004020202020204" pitchFamily="34" charset="0"/>
                <a:cs typeface="Times New Roman" panose="02020603050405020304" pitchFamily="18" charset="0"/>
              </a:rPr>
              <a:t>44</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C) Gene set enrichment analysis of patients excluding patient 1010 and 1019 harbouring HR deficiencies. (D) Gene set enrichment analysis of patients within the DARANA trial. Genes were ranked by Log2Fold change, with respect to pre-treatment control samples. Enrichment analysis was performed using the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MSigDB</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cancer hallmarks and expression signatures relating to homologous recombination deficiency. (E) Correlation between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Prolaris</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and </a:t>
            </a:r>
            <a:r>
              <a:rPr lang="en-GB" sz="1800" kern="100" dirty="0" err="1">
                <a:effectLst/>
                <a:latin typeface="Aptos" panose="020B0004020202020204" pitchFamily="34" charset="0"/>
                <a:ea typeface="Aptos" panose="020B0004020202020204" pitchFamily="34" charset="0"/>
                <a:cs typeface="Times New Roman" panose="02020603050405020304" pitchFamily="18" charset="0"/>
              </a:rPr>
              <a:t>HRD_down</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 expression changes from patients in the DARANA study</a:t>
            </a:r>
            <a:r>
              <a:rPr lang="en-GB" sz="1800" kern="100" baseline="30000" dirty="0">
                <a:effectLst/>
                <a:latin typeface="Aptos" panose="020B0004020202020204" pitchFamily="34" charset="0"/>
                <a:ea typeface="Aptos" panose="020B0004020202020204" pitchFamily="34" charset="0"/>
                <a:cs typeface="Times New Roman" panose="02020603050405020304" pitchFamily="18" charset="0"/>
              </a:rPr>
              <a:t>36</a:t>
            </a:r>
            <a:r>
              <a:rPr lang="en-GB" sz="1800" kern="100" dirty="0">
                <a:effectLst/>
                <a:latin typeface="Aptos" panose="020B0004020202020204" pitchFamily="34" charset="0"/>
                <a:ea typeface="Aptos" panose="020B0004020202020204" pitchFamily="34" charset="0"/>
                <a:cs typeface="Times New Roman" panose="02020603050405020304" pitchFamily="18" charset="0"/>
              </a:rPr>
              <a:t>.</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3820358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TotalTime>
  <Words>142</Words>
  <Application>Microsoft Office PowerPoint</Application>
  <PresentationFormat>Widescreen</PresentationFormat>
  <Paragraphs>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egmann, Bill</dc:creator>
  <cp:lastModifiedBy>Siegmann, Bill</cp:lastModifiedBy>
  <cp:revision>1</cp:revision>
  <dcterms:created xsi:type="dcterms:W3CDTF">2025-04-08T14:48:56Z</dcterms:created>
  <dcterms:modified xsi:type="dcterms:W3CDTF">2025-04-08T14:49:59Z</dcterms:modified>
</cp:coreProperties>
</file>